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10" autoAdjust="0"/>
    <p:restoredTop sz="94660"/>
  </p:normalViewPr>
  <p:slideViewPr>
    <p:cSldViewPr snapToGrid="0">
      <p:cViewPr>
        <p:scale>
          <a:sx n="100" d="100"/>
          <a:sy n="100" d="100"/>
        </p:scale>
        <p:origin x="-228" y="-7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68D96E-0CED-46F6-A409-C96367EDD023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917210-454A-488C-AA18-C1CBB9BA7F0F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8174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b="1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917210-454A-488C-AA18-C1CBB9BA7F0F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5669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971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818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9819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158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5008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7586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2282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6853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7377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1174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475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425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4852262" y="6218756"/>
            <a:ext cx="1847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165962" y="214640"/>
            <a:ext cx="93725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ox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lot of mean alpha diversity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btained by combining the data on infants born from mothers receiving IAP (n=18) or those whose mothers did not receive IAP (n=22) at 2, 10, 30 and 90 days of age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0425" y="1001713"/>
            <a:ext cx="8185150" cy="4854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3130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8</TotalTime>
  <Words>48</Words>
  <Application>Microsoft Office PowerPoint</Application>
  <PresentationFormat>A4 (210 x 297 mm)</PresentationFormat>
  <Paragraphs>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</dc:creator>
  <cp:lastModifiedBy>MGueimonde</cp:lastModifiedBy>
  <cp:revision>27</cp:revision>
  <dcterms:created xsi:type="dcterms:W3CDTF">2015-07-08T13:06:08Z</dcterms:created>
  <dcterms:modified xsi:type="dcterms:W3CDTF">2017-06-26T11:39:12Z</dcterms:modified>
</cp:coreProperties>
</file>